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591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660"/>
  </p:normalViewPr>
  <p:slideViewPr>
    <p:cSldViewPr snapToGrid="0">
      <p:cViewPr varScale="1">
        <p:scale>
          <a:sx n="100" d="100"/>
          <a:sy n="100" d="100"/>
        </p:scale>
        <p:origin x="9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171809-84EB-728D-6053-3FA42E4937E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22E8F46-367E-25C2-9CD1-00B1554C42D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61AD684-4078-EDDA-0F9B-6994637F7C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7507C-0DBF-4112-92BE-B899CC8BA231}" type="datetimeFigureOut">
              <a:rPr lang="en-US" smtClean="0"/>
              <a:t>2/26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9C886FC-CD3C-41E8-D7BF-CF4142EBD7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B4C5949-5EAD-0DB3-DD1E-5478E7D37D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B442E2-722C-4288-942A-5BE5272DD7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99275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5AABC1-CD5E-5EFF-89D4-D6A325D3FA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0F2041E-2EFA-6D80-3C3A-A4B7E97BB1D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6DDB4F4-0251-504B-844F-7CE3F692E4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7507C-0DBF-4112-92BE-B899CC8BA231}" type="datetimeFigureOut">
              <a:rPr lang="en-US" smtClean="0"/>
              <a:t>2/26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CD5FEC3-CB81-B83D-F168-BFAE006E7D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A68F54-080F-8B7E-772B-ED00526573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B442E2-722C-4288-942A-5BE5272DD7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41385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3C94210-6013-D5CD-DAC2-5098BCD6A8A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1DD018F-40B1-F496-8F28-F9917E9B641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5F4ECFF-4B4E-6B8D-6694-4C054DA2E5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7507C-0DBF-4112-92BE-B899CC8BA231}" type="datetimeFigureOut">
              <a:rPr lang="en-US" smtClean="0"/>
              <a:t>2/26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F788D37-7CB7-7DF4-8302-6B344BE8F2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FD12FAA-824C-BF39-6106-EF191B5300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B442E2-722C-4288-942A-5BE5272DD7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00810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BBA225-1AA9-4B2E-698A-07F98457B99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D560AC9-F28E-0B9B-ABE1-3DEF3BB7ECD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4A9E263-F052-7FDA-CF76-08E3EBAE9C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7507C-0DBF-4112-92BE-B899CC8BA231}" type="datetimeFigureOut">
              <a:rPr lang="en-US" smtClean="0"/>
              <a:t>2/26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F434D50-6756-5A7D-3BC7-284AD18005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11B3E6-64C5-021B-5971-3E3EABCFF8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B442E2-722C-4288-942A-5BE5272DD7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89248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DA577B-F353-3395-C642-23A37E58FE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EEA07F5-EAE2-C8D3-A971-43EF3E842D1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C22B12A-DC6D-1FD9-B2D2-862BD2EC58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7507C-0DBF-4112-92BE-B899CC8BA231}" type="datetimeFigureOut">
              <a:rPr lang="en-US" smtClean="0"/>
              <a:t>2/26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6CD478E-AB42-5C55-06BC-6A3FCC22B8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AFB234F-EE17-E117-0660-AD3A984268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B442E2-722C-4288-942A-5BE5272DD7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16530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7F54979-A720-F51B-11A0-0956DEADE1F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4E2E23F-4040-DE56-C8B2-406952840C5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B5F3886-A9C3-942A-F942-48F28ABE2B4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23AA20B-3582-F132-1682-EFCE77F952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7507C-0DBF-4112-92BE-B899CC8BA231}" type="datetimeFigureOut">
              <a:rPr lang="en-US" smtClean="0"/>
              <a:t>2/26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8B3E350-F99D-3C60-ACB6-5A5D50DD1A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72A48B3-E627-52AC-C493-E9C2465A2C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B442E2-722C-4288-942A-5BE5272DD7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62406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6188257-498A-A061-23D8-7AB7DEF930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68676AC-D607-CB84-1397-E2753F87C32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F20CC96-059D-7937-0BDC-E10884A73F2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8AB2BD1-941B-A974-C453-1A9B0A7A125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E964FB9-7E82-166B-8E8F-92B34538A85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4B5B1E9-25BC-A446-B195-3CF9944400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7507C-0DBF-4112-92BE-B899CC8BA231}" type="datetimeFigureOut">
              <a:rPr lang="en-US" smtClean="0"/>
              <a:t>2/26/2026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6D8308F-006C-5C1A-D2D7-B7B9545C52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89122EC-0F98-9842-AFCD-A1D61F5982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B442E2-722C-4288-942A-5BE5272DD7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25754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2EDE35-960C-5D70-0975-D838E76595D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4F01722-2857-98DF-8EC6-E1C6C171CE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7507C-0DBF-4112-92BE-B899CC8BA231}" type="datetimeFigureOut">
              <a:rPr lang="en-US" smtClean="0"/>
              <a:t>2/26/2026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CF152B0-298B-4628-75E0-BE0FFF4191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FC6B53F-37F1-50B0-41E9-4CE68CB9FF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B442E2-722C-4288-942A-5BE5272DD7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28636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03A9F24-CD29-9F21-C118-2E9838586B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7507C-0DBF-4112-92BE-B899CC8BA231}" type="datetimeFigureOut">
              <a:rPr lang="en-US" smtClean="0"/>
              <a:t>2/26/2026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CB858D9-2463-D8BC-D20B-DBA0340D3F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90FA327-EC93-C4AC-AD50-994B9E0A0C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B442E2-722C-4288-942A-5BE5272DD7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64285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FCB03F-9847-C305-79C1-1002A472E4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AB7C495-60EC-1D44-A86D-63F016809FE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C784E4C-DE5B-1E82-7EAC-B5A8BC10404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E859101-E9AE-1526-144E-60EF9E7E8E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7507C-0DBF-4112-92BE-B899CC8BA231}" type="datetimeFigureOut">
              <a:rPr lang="en-US" smtClean="0"/>
              <a:t>2/26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512E089-DB36-5F97-9D05-91B1EBB223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2E68142-85B6-F708-E1F5-482AFDF2F5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B442E2-722C-4288-942A-5BE5272DD7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84236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AE85FD-0477-349D-C459-8C2B98435F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3F4FC84-ECF1-1506-AC52-FD47F2EA653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7D58F79-D79B-205A-F000-98CCE3E9825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CABFFA4-0C26-DEB3-C56B-EEC956A190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7507C-0DBF-4112-92BE-B899CC8BA231}" type="datetimeFigureOut">
              <a:rPr lang="en-US" smtClean="0"/>
              <a:t>2/26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9661803-1EE9-B997-2AEA-9E814345E4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29D3228-F668-D74B-4C5F-156CFDD551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B442E2-722C-4288-942A-5BE5272DD7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42163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F6D8A09-E747-828F-A10B-F52707DC89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FF18A04-B462-A53E-3640-3628B2E8EDE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1682162-C704-7497-9487-92C16817281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6A7507C-0DBF-4112-92BE-B899CC8BA231}" type="datetimeFigureOut">
              <a:rPr lang="en-US" smtClean="0"/>
              <a:t>2/26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52369F4-0CD6-C663-BBF0-7B94690E7DB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37AA8E1-1188-7B45-C931-2918D0AF69F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4B442E2-722C-4288-942A-5BE5272DD7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73510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3" Type="http://schemas.openxmlformats.org/officeDocument/2006/relationships/image" Target="../media/image2.png"/><Relationship Id="rId21" Type="http://schemas.openxmlformats.org/officeDocument/2006/relationships/image" Target="../media/image20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20" Type="http://schemas.openxmlformats.org/officeDocument/2006/relationships/image" Target="../media/image1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23" Type="http://schemas.openxmlformats.org/officeDocument/2006/relationships/image" Target="../media/image22.png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Relationship Id="rId22" Type="http://schemas.openxmlformats.org/officeDocument/2006/relationships/image" Target="../media/image2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Picture 14">
            <a:extLst>
              <a:ext uri="{FF2B5EF4-FFF2-40B4-BE49-F238E27FC236}">
                <a16:creationId xmlns:a16="http://schemas.microsoft.com/office/drawing/2014/main" id="{EC3979A5-C2F6-4481-4F5E-30FA5997F12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683562" y="310047"/>
            <a:ext cx="1393365" cy="1371600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80E37BF7-4347-663A-9382-6C6327F6FFB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696450" y="1679377"/>
            <a:ext cx="1393365" cy="1371600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B7F2B635-2DA8-4C0A-808A-5668404D8C6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683561" y="3050977"/>
            <a:ext cx="1393365" cy="1371600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E905240A-16AA-E7C1-A8B8-AB716507CD3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670672" y="4420307"/>
            <a:ext cx="1393365" cy="1371600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94480B61-4781-985F-8D15-88A22552E18B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9683561" y="5869609"/>
            <a:ext cx="1393365" cy="1371600"/>
          </a:xfrm>
          <a:prstGeom prst="rect">
            <a:avLst/>
          </a:prstGeom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9850D3CD-F6EF-0C88-0DDB-58633CCA7303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196994" y="311154"/>
            <a:ext cx="1393365" cy="1371600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0258713C-8072-10EB-8D2A-04CFD7B9EF25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8196994" y="1679377"/>
            <a:ext cx="1393365" cy="1371600"/>
          </a:xfrm>
          <a:prstGeom prst="rect">
            <a:avLst/>
          </a:prstGeom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929643ED-1948-9CD4-AFFA-616145D4EFB6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8209882" y="3050977"/>
            <a:ext cx="1393365" cy="1371600"/>
          </a:xfrm>
          <a:prstGeom prst="rect">
            <a:avLst/>
          </a:prstGeom>
        </p:spPr>
      </p:pic>
      <p:pic>
        <p:nvPicPr>
          <p:cNvPr id="31" name="Picture 30">
            <a:extLst>
              <a:ext uri="{FF2B5EF4-FFF2-40B4-BE49-F238E27FC236}">
                <a16:creationId xmlns:a16="http://schemas.microsoft.com/office/drawing/2014/main" id="{020218E2-1FAC-33CF-773B-FF8134C1A040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8177464" y="4459636"/>
            <a:ext cx="1393365" cy="1371600"/>
          </a:xfrm>
          <a:prstGeom prst="rect">
            <a:avLst/>
          </a:prstGeom>
        </p:spPr>
      </p:pic>
      <p:pic>
        <p:nvPicPr>
          <p:cNvPr id="33" name="Picture 32">
            <a:extLst>
              <a:ext uri="{FF2B5EF4-FFF2-40B4-BE49-F238E27FC236}">
                <a16:creationId xmlns:a16="http://schemas.microsoft.com/office/drawing/2014/main" id="{42BC75F2-6C36-D320-C3E1-3D87B2E645F9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8177465" y="5868296"/>
            <a:ext cx="1393365" cy="1371600"/>
          </a:xfrm>
          <a:prstGeom prst="rect">
            <a:avLst/>
          </a:prstGeom>
        </p:spPr>
      </p:pic>
      <p:pic>
        <p:nvPicPr>
          <p:cNvPr id="35" name="Picture 34">
            <a:extLst>
              <a:ext uri="{FF2B5EF4-FFF2-40B4-BE49-F238E27FC236}">
                <a16:creationId xmlns:a16="http://schemas.microsoft.com/office/drawing/2014/main" id="{18A21DC8-EBE9-F9E7-DD7E-008355EDB745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6694097" y="5886789"/>
            <a:ext cx="1393365" cy="1371600"/>
          </a:xfrm>
          <a:prstGeom prst="rect">
            <a:avLst/>
          </a:prstGeom>
        </p:spPr>
      </p:pic>
      <p:pic>
        <p:nvPicPr>
          <p:cNvPr id="37" name="Picture 36">
            <a:extLst>
              <a:ext uri="{FF2B5EF4-FFF2-40B4-BE49-F238E27FC236}">
                <a16:creationId xmlns:a16="http://schemas.microsoft.com/office/drawing/2014/main" id="{EB8039E6-8D36-F92C-29AA-2CC6E6D0C2EF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6710426" y="4500073"/>
            <a:ext cx="1393365" cy="1371600"/>
          </a:xfrm>
          <a:prstGeom prst="rect">
            <a:avLst/>
          </a:prstGeom>
        </p:spPr>
      </p:pic>
      <p:pic>
        <p:nvPicPr>
          <p:cNvPr id="39" name="Picture 38">
            <a:extLst>
              <a:ext uri="{FF2B5EF4-FFF2-40B4-BE49-F238E27FC236}">
                <a16:creationId xmlns:a16="http://schemas.microsoft.com/office/drawing/2014/main" id="{02C57DEB-7F88-4662-2D33-59D864476788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6710426" y="3097493"/>
            <a:ext cx="1393365" cy="1371600"/>
          </a:xfrm>
          <a:prstGeom prst="rect">
            <a:avLst/>
          </a:prstGeom>
        </p:spPr>
      </p:pic>
      <p:pic>
        <p:nvPicPr>
          <p:cNvPr id="41" name="Picture 40">
            <a:extLst>
              <a:ext uri="{FF2B5EF4-FFF2-40B4-BE49-F238E27FC236}">
                <a16:creationId xmlns:a16="http://schemas.microsoft.com/office/drawing/2014/main" id="{316CEBA2-476C-2B30-DA27-BCCD63CCB6A8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6710426" y="1681647"/>
            <a:ext cx="1393365" cy="1371600"/>
          </a:xfrm>
          <a:prstGeom prst="rect">
            <a:avLst/>
          </a:prstGeom>
        </p:spPr>
      </p:pic>
      <p:pic>
        <p:nvPicPr>
          <p:cNvPr id="43" name="Picture 42">
            <a:extLst>
              <a:ext uri="{FF2B5EF4-FFF2-40B4-BE49-F238E27FC236}">
                <a16:creationId xmlns:a16="http://schemas.microsoft.com/office/drawing/2014/main" id="{52875ED1-8421-B488-9F6F-ACA3F5EFE836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6694098" y="310047"/>
            <a:ext cx="1393365" cy="1371600"/>
          </a:xfrm>
          <a:prstGeom prst="rect">
            <a:avLst/>
          </a:prstGeom>
        </p:spPr>
      </p:pic>
      <p:pic>
        <p:nvPicPr>
          <p:cNvPr id="45" name="Picture 44">
            <a:extLst>
              <a:ext uri="{FF2B5EF4-FFF2-40B4-BE49-F238E27FC236}">
                <a16:creationId xmlns:a16="http://schemas.microsoft.com/office/drawing/2014/main" id="{73C6B744-B8BA-341C-5E9C-B1D3615A7092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5191202" y="310047"/>
            <a:ext cx="1393365" cy="1371600"/>
          </a:xfrm>
          <a:prstGeom prst="rect">
            <a:avLst/>
          </a:prstGeom>
        </p:spPr>
      </p:pic>
      <p:pic>
        <p:nvPicPr>
          <p:cNvPr id="47" name="Picture 46">
            <a:extLst>
              <a:ext uri="{FF2B5EF4-FFF2-40B4-BE49-F238E27FC236}">
                <a16:creationId xmlns:a16="http://schemas.microsoft.com/office/drawing/2014/main" id="{360CA44B-FA45-F3E0-8DFF-F3B40A10CCBB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5177415" y="1681647"/>
            <a:ext cx="1393365" cy="1371600"/>
          </a:xfrm>
          <a:prstGeom prst="rect">
            <a:avLst/>
          </a:prstGeom>
        </p:spPr>
      </p:pic>
      <p:pic>
        <p:nvPicPr>
          <p:cNvPr id="49" name="Picture 48">
            <a:extLst>
              <a:ext uri="{FF2B5EF4-FFF2-40B4-BE49-F238E27FC236}">
                <a16:creationId xmlns:a16="http://schemas.microsoft.com/office/drawing/2014/main" id="{9F594764-A5AE-2EF2-0515-9588661FCE9E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5166889" y="3097493"/>
            <a:ext cx="1393365" cy="1371600"/>
          </a:xfrm>
          <a:prstGeom prst="rect">
            <a:avLst/>
          </a:prstGeom>
        </p:spPr>
      </p:pic>
      <p:pic>
        <p:nvPicPr>
          <p:cNvPr id="51" name="Picture 50">
            <a:extLst>
              <a:ext uri="{FF2B5EF4-FFF2-40B4-BE49-F238E27FC236}">
                <a16:creationId xmlns:a16="http://schemas.microsoft.com/office/drawing/2014/main" id="{64C70D2E-1C6A-135B-E029-1A7F7890D513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5156675" y="4500073"/>
            <a:ext cx="1393365" cy="1371600"/>
          </a:xfrm>
          <a:prstGeom prst="rect">
            <a:avLst/>
          </a:prstGeom>
        </p:spPr>
      </p:pic>
      <p:pic>
        <p:nvPicPr>
          <p:cNvPr id="53" name="Picture 52">
            <a:extLst>
              <a:ext uri="{FF2B5EF4-FFF2-40B4-BE49-F238E27FC236}">
                <a16:creationId xmlns:a16="http://schemas.microsoft.com/office/drawing/2014/main" id="{E9070B39-8B8B-0033-D81E-4B6DAFA340B9}"/>
              </a:ext>
            </a:extLst>
          </p:cNvPr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5124020" y="5871673"/>
            <a:ext cx="1393365" cy="1371600"/>
          </a:xfrm>
          <a:prstGeom prst="rect">
            <a:avLst/>
          </a:prstGeom>
        </p:spPr>
      </p:pic>
      <p:sp>
        <p:nvSpPr>
          <p:cNvPr id="54" name="TextBox 53">
            <a:extLst>
              <a:ext uri="{FF2B5EF4-FFF2-40B4-BE49-F238E27FC236}">
                <a16:creationId xmlns:a16="http://schemas.microsoft.com/office/drawing/2014/main" id="{D37068C8-45E2-6FB5-1DE2-44A8F6AF303B}"/>
              </a:ext>
            </a:extLst>
          </p:cNvPr>
          <p:cNvSpPr txBox="1"/>
          <p:nvPr/>
        </p:nvSpPr>
        <p:spPr>
          <a:xfrm>
            <a:off x="4591489" y="3492825"/>
            <a:ext cx="6291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RSL3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9E6F26A1-04B1-2EA2-4882-83E9E821A421}"/>
              </a:ext>
            </a:extLst>
          </p:cNvPr>
          <p:cNvSpPr txBox="1"/>
          <p:nvPr/>
        </p:nvSpPr>
        <p:spPr>
          <a:xfrm>
            <a:off x="3899492" y="4864425"/>
            <a:ext cx="13933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Fer-1+RSL3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FEC01AAD-7388-3D73-A5B6-A0BE61A72460}"/>
              </a:ext>
            </a:extLst>
          </p:cNvPr>
          <p:cNvSpPr txBox="1"/>
          <p:nvPr/>
        </p:nvSpPr>
        <p:spPr>
          <a:xfrm>
            <a:off x="4592476" y="2108886"/>
            <a:ext cx="55568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Fer-1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17420EF5-21DC-6631-9A84-92915BF84F06}"/>
              </a:ext>
            </a:extLst>
          </p:cNvPr>
          <p:cNvSpPr txBox="1"/>
          <p:nvPr/>
        </p:nvSpPr>
        <p:spPr>
          <a:xfrm>
            <a:off x="4595365" y="797112"/>
            <a:ext cx="62530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1D580659-9FF8-BB0F-0C2E-16A8F9E127B6}"/>
              </a:ext>
            </a:extLst>
          </p:cNvPr>
          <p:cNvSpPr txBox="1"/>
          <p:nvPr/>
        </p:nvSpPr>
        <p:spPr>
          <a:xfrm>
            <a:off x="4033092" y="6202868"/>
            <a:ext cx="118758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umene</a:t>
            </a:r>
          </a:p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Hydroperoxide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C0306C01-062B-453E-72F7-28701F42F8ED}"/>
              </a:ext>
            </a:extLst>
          </p:cNvPr>
          <p:cNvSpPr txBox="1"/>
          <p:nvPr/>
        </p:nvSpPr>
        <p:spPr>
          <a:xfrm>
            <a:off x="5756909" y="2270"/>
            <a:ext cx="638175" cy="307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CTL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C684CE69-94E5-2AD1-093B-0526D14740B6}"/>
              </a:ext>
            </a:extLst>
          </p:cNvPr>
          <p:cNvSpPr txBox="1"/>
          <p:nvPr/>
        </p:nvSpPr>
        <p:spPr>
          <a:xfrm>
            <a:off x="7315200" y="8875"/>
            <a:ext cx="516105" cy="307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FL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FC4CE11C-522A-52C2-C667-917B01CEB9B6}"/>
              </a:ext>
            </a:extLst>
          </p:cNvPr>
          <p:cNvSpPr txBox="1"/>
          <p:nvPr/>
        </p:nvSpPr>
        <p:spPr>
          <a:xfrm>
            <a:off x="8811403" y="8875"/>
            <a:ext cx="516105" cy="307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NT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C93E7ECD-D0E0-630F-274E-93894DF52415}"/>
              </a:ext>
            </a:extLst>
          </p:cNvPr>
          <p:cNvSpPr txBox="1"/>
          <p:nvPr/>
        </p:nvSpPr>
        <p:spPr>
          <a:xfrm>
            <a:off x="10252064" y="0"/>
            <a:ext cx="516105" cy="307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CT</a:t>
            </a:r>
          </a:p>
        </p:txBody>
      </p:sp>
      <p:pic>
        <p:nvPicPr>
          <p:cNvPr id="68" name="Picture 67">
            <a:extLst>
              <a:ext uri="{FF2B5EF4-FFF2-40B4-BE49-F238E27FC236}">
                <a16:creationId xmlns:a16="http://schemas.microsoft.com/office/drawing/2014/main" id="{111E4780-066B-7191-F004-D0760ABD750F}"/>
              </a:ext>
            </a:extLst>
          </p:cNvPr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1395136" y="2317139"/>
            <a:ext cx="1985269" cy="1918281"/>
          </a:xfrm>
          <a:prstGeom prst="rect">
            <a:avLst/>
          </a:prstGeom>
        </p:spPr>
      </p:pic>
      <p:pic>
        <p:nvPicPr>
          <p:cNvPr id="70" name="Picture 69">
            <a:extLst>
              <a:ext uri="{FF2B5EF4-FFF2-40B4-BE49-F238E27FC236}">
                <a16:creationId xmlns:a16="http://schemas.microsoft.com/office/drawing/2014/main" id="{E2882375-9595-AA4C-2CD2-F6272EAF1B95}"/>
              </a:ext>
            </a:extLst>
          </p:cNvPr>
          <p:cNvPicPr>
            <a:picLocks noChangeAspect="1"/>
          </p:cNvPicPr>
          <p:nvPr/>
        </p:nvPicPr>
        <p:blipFill>
          <a:blip r:embed="rId23"/>
          <a:srcRect r="55024" b="13175"/>
          <a:stretch/>
        </p:blipFill>
        <p:spPr>
          <a:xfrm>
            <a:off x="1395136" y="297941"/>
            <a:ext cx="1924453" cy="1918281"/>
          </a:xfrm>
          <a:prstGeom prst="rect">
            <a:avLst/>
          </a:prstGeom>
        </p:spPr>
      </p:pic>
      <p:pic>
        <p:nvPicPr>
          <p:cNvPr id="72" name="Picture 71">
            <a:extLst>
              <a:ext uri="{FF2B5EF4-FFF2-40B4-BE49-F238E27FC236}">
                <a16:creationId xmlns:a16="http://schemas.microsoft.com/office/drawing/2014/main" id="{49C0DEC2-94A4-7725-7F2C-DF9F0DE9FFED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1453290" y="4393171"/>
            <a:ext cx="1906046" cy="1813970"/>
          </a:xfrm>
          <a:prstGeom prst="rect">
            <a:avLst/>
          </a:prstGeom>
        </p:spPr>
      </p:pic>
      <p:sp>
        <p:nvSpPr>
          <p:cNvPr id="74" name="TextBox 73">
            <a:extLst>
              <a:ext uri="{FF2B5EF4-FFF2-40B4-BE49-F238E27FC236}">
                <a16:creationId xmlns:a16="http://schemas.microsoft.com/office/drawing/2014/main" id="{A5FE180E-81D4-7A3E-72B5-767D81BEAF99}"/>
              </a:ext>
            </a:extLst>
          </p:cNvPr>
          <p:cNvSpPr txBox="1"/>
          <p:nvPr/>
        </p:nvSpPr>
        <p:spPr>
          <a:xfrm>
            <a:off x="1002657" y="373258"/>
            <a:ext cx="4717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A.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06FB8939-4587-B982-0701-FD1910D5118B}"/>
              </a:ext>
            </a:extLst>
          </p:cNvPr>
          <p:cNvSpPr txBox="1"/>
          <p:nvPr/>
        </p:nvSpPr>
        <p:spPr>
          <a:xfrm>
            <a:off x="4900554" y="169849"/>
            <a:ext cx="4717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B.</a:t>
            </a:r>
          </a:p>
        </p:txBody>
      </p:sp>
      <p:cxnSp>
        <p:nvCxnSpPr>
          <p:cNvPr id="77" name="Straight Arrow Connector 76">
            <a:extLst>
              <a:ext uri="{FF2B5EF4-FFF2-40B4-BE49-F238E27FC236}">
                <a16:creationId xmlns:a16="http://schemas.microsoft.com/office/drawing/2014/main" id="{ECA88F39-87D7-7631-A641-F80B62C1C0D4}"/>
              </a:ext>
            </a:extLst>
          </p:cNvPr>
          <p:cNvCxnSpPr>
            <a:cxnSpLocks/>
          </p:cNvCxnSpPr>
          <p:nvPr/>
        </p:nvCxnSpPr>
        <p:spPr>
          <a:xfrm>
            <a:off x="2535634" y="2171735"/>
            <a:ext cx="0" cy="189891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79" name="Straight Arrow Connector 78">
            <a:extLst>
              <a:ext uri="{FF2B5EF4-FFF2-40B4-BE49-F238E27FC236}">
                <a16:creationId xmlns:a16="http://schemas.microsoft.com/office/drawing/2014/main" id="{06AB2E71-EDE4-7CE8-FE62-26EF7CDD6A67}"/>
              </a:ext>
            </a:extLst>
          </p:cNvPr>
          <p:cNvCxnSpPr>
            <a:cxnSpLocks/>
          </p:cNvCxnSpPr>
          <p:nvPr/>
        </p:nvCxnSpPr>
        <p:spPr>
          <a:xfrm>
            <a:off x="2535634" y="4254470"/>
            <a:ext cx="0" cy="189891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80" name="TextBox 79">
            <a:extLst>
              <a:ext uri="{FF2B5EF4-FFF2-40B4-BE49-F238E27FC236}">
                <a16:creationId xmlns:a16="http://schemas.microsoft.com/office/drawing/2014/main" id="{A842E9D5-7F20-1AEE-45C3-18EC98B5BD9A}"/>
              </a:ext>
            </a:extLst>
          </p:cNvPr>
          <p:cNvSpPr txBox="1"/>
          <p:nvPr/>
        </p:nvSpPr>
        <p:spPr>
          <a:xfrm>
            <a:off x="6570780" y="141042"/>
            <a:ext cx="4717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C.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5157FD53-B7B4-4E84-92A7-38EA05504FCA}"/>
              </a:ext>
            </a:extLst>
          </p:cNvPr>
          <p:cNvSpPr txBox="1"/>
          <p:nvPr/>
        </p:nvSpPr>
        <p:spPr>
          <a:xfrm>
            <a:off x="8113242" y="116829"/>
            <a:ext cx="4717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D.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4F374CE4-8058-6102-2342-FC943DE704AA}"/>
              </a:ext>
            </a:extLst>
          </p:cNvPr>
          <p:cNvSpPr txBox="1"/>
          <p:nvPr/>
        </p:nvSpPr>
        <p:spPr>
          <a:xfrm>
            <a:off x="9617558" y="103838"/>
            <a:ext cx="4717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E.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08DDBA9F-4DE3-7317-42A3-4E7D1D08AAB1}"/>
              </a:ext>
            </a:extLst>
          </p:cNvPr>
          <p:cNvSpPr txBox="1"/>
          <p:nvPr/>
        </p:nvSpPr>
        <p:spPr>
          <a:xfrm>
            <a:off x="4880716" y="1505636"/>
            <a:ext cx="4717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F.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F2A8117C-C24C-8AFE-BECE-01A07C48F094}"/>
              </a:ext>
            </a:extLst>
          </p:cNvPr>
          <p:cNvSpPr txBox="1"/>
          <p:nvPr/>
        </p:nvSpPr>
        <p:spPr>
          <a:xfrm>
            <a:off x="6543581" y="1553899"/>
            <a:ext cx="4717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G.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22AC79AD-0FCE-8835-25C8-D9DA490951CF}"/>
              </a:ext>
            </a:extLst>
          </p:cNvPr>
          <p:cNvSpPr txBox="1"/>
          <p:nvPr/>
        </p:nvSpPr>
        <p:spPr>
          <a:xfrm>
            <a:off x="8086043" y="1529686"/>
            <a:ext cx="4717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H.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DB53B907-8081-E0B4-1420-E2743FC7D97C}"/>
              </a:ext>
            </a:extLst>
          </p:cNvPr>
          <p:cNvSpPr txBox="1"/>
          <p:nvPr/>
        </p:nvSpPr>
        <p:spPr>
          <a:xfrm>
            <a:off x="9590359" y="1516695"/>
            <a:ext cx="4717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I.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23401824-5CCD-1A91-9550-0F5E770BE007}"/>
              </a:ext>
            </a:extLst>
          </p:cNvPr>
          <p:cNvSpPr txBox="1"/>
          <p:nvPr/>
        </p:nvSpPr>
        <p:spPr>
          <a:xfrm>
            <a:off x="4902981" y="2868314"/>
            <a:ext cx="4717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J.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B19136F6-4150-206F-4D7A-408736FCABEB}"/>
              </a:ext>
            </a:extLst>
          </p:cNvPr>
          <p:cNvSpPr txBox="1"/>
          <p:nvPr/>
        </p:nvSpPr>
        <p:spPr>
          <a:xfrm>
            <a:off x="6565846" y="2916577"/>
            <a:ext cx="4717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K.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F3E17242-496D-D239-5AC7-5DD257F652BE}"/>
              </a:ext>
            </a:extLst>
          </p:cNvPr>
          <p:cNvSpPr txBox="1"/>
          <p:nvPr/>
        </p:nvSpPr>
        <p:spPr>
          <a:xfrm>
            <a:off x="8108308" y="2892364"/>
            <a:ext cx="4717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L.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A1BECE74-1DA5-B648-EC98-8896A5592B64}"/>
              </a:ext>
            </a:extLst>
          </p:cNvPr>
          <p:cNvSpPr txBox="1"/>
          <p:nvPr/>
        </p:nvSpPr>
        <p:spPr>
          <a:xfrm>
            <a:off x="9612624" y="2879373"/>
            <a:ext cx="4717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M.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5DA1A464-B77F-D5E5-AAB6-240F1A7E2A04}"/>
              </a:ext>
            </a:extLst>
          </p:cNvPr>
          <p:cNvSpPr txBox="1"/>
          <p:nvPr/>
        </p:nvSpPr>
        <p:spPr>
          <a:xfrm>
            <a:off x="4926217" y="4231946"/>
            <a:ext cx="4717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N.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E28E4C09-F3F5-5F99-85B5-C96440C825A5}"/>
              </a:ext>
            </a:extLst>
          </p:cNvPr>
          <p:cNvSpPr txBox="1"/>
          <p:nvPr/>
        </p:nvSpPr>
        <p:spPr>
          <a:xfrm>
            <a:off x="6589082" y="4280209"/>
            <a:ext cx="4717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O.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94AEC2CD-93B2-9F82-0B99-DED9D475B370}"/>
              </a:ext>
            </a:extLst>
          </p:cNvPr>
          <p:cNvSpPr txBox="1"/>
          <p:nvPr/>
        </p:nvSpPr>
        <p:spPr>
          <a:xfrm>
            <a:off x="8131544" y="4255996"/>
            <a:ext cx="4717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P.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E99CC56B-C53B-F8E4-FE82-248E81A4786E}"/>
              </a:ext>
            </a:extLst>
          </p:cNvPr>
          <p:cNvSpPr txBox="1"/>
          <p:nvPr/>
        </p:nvSpPr>
        <p:spPr>
          <a:xfrm>
            <a:off x="9635860" y="4243005"/>
            <a:ext cx="4717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Q.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8895267F-1115-32D9-F9ED-C7DE5B4E4453}"/>
              </a:ext>
            </a:extLst>
          </p:cNvPr>
          <p:cNvSpPr txBox="1"/>
          <p:nvPr/>
        </p:nvSpPr>
        <p:spPr>
          <a:xfrm>
            <a:off x="4948140" y="5631945"/>
            <a:ext cx="4717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R.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0FB61F56-0A76-103D-7D89-0E39C00F71AB}"/>
              </a:ext>
            </a:extLst>
          </p:cNvPr>
          <p:cNvSpPr txBox="1"/>
          <p:nvPr/>
        </p:nvSpPr>
        <p:spPr>
          <a:xfrm>
            <a:off x="6611005" y="5680208"/>
            <a:ext cx="4717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S.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4005F293-7D81-BE6D-C962-FFF5785A3526}"/>
              </a:ext>
            </a:extLst>
          </p:cNvPr>
          <p:cNvSpPr txBox="1"/>
          <p:nvPr/>
        </p:nvSpPr>
        <p:spPr>
          <a:xfrm>
            <a:off x="8153467" y="5655995"/>
            <a:ext cx="4717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T.</a:t>
            </a: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F06C6830-F942-A7C7-B939-BC7BC7B98B84}"/>
              </a:ext>
            </a:extLst>
          </p:cNvPr>
          <p:cNvSpPr txBox="1"/>
          <p:nvPr/>
        </p:nvSpPr>
        <p:spPr>
          <a:xfrm>
            <a:off x="9657783" y="5643004"/>
            <a:ext cx="4717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U.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F531A90F-68EB-B769-6EB4-04022258644E}"/>
              </a:ext>
            </a:extLst>
          </p:cNvPr>
          <p:cNvSpPr txBox="1"/>
          <p:nvPr/>
        </p:nvSpPr>
        <p:spPr>
          <a:xfrm>
            <a:off x="127461" y="-33732"/>
            <a:ext cx="25321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lemental Figure 5</a:t>
            </a:r>
          </a:p>
        </p:txBody>
      </p:sp>
    </p:spTree>
    <p:extLst>
      <p:ext uri="{BB962C8B-B14F-4D97-AF65-F5344CB8AC3E}">
        <p14:creationId xmlns:p14="http://schemas.microsoft.com/office/powerpoint/2010/main" val="8636938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57</Words>
  <Application>Microsoft Office PowerPoint</Application>
  <PresentationFormat>Widescreen</PresentationFormat>
  <Paragraphs>3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Burnett, Andrean L</dc:creator>
  <cp:lastModifiedBy>Burnett, Andrean L</cp:lastModifiedBy>
  <cp:revision>7</cp:revision>
  <dcterms:created xsi:type="dcterms:W3CDTF">2026-02-26T15:58:59Z</dcterms:created>
  <dcterms:modified xsi:type="dcterms:W3CDTF">2026-02-26T16:02:47Z</dcterms:modified>
</cp:coreProperties>
</file>